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080625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E3BF1-5B77-45EE-8D91-993F97CDA8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680076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7640" y="5831280"/>
            <a:ext cx="680076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4D968-10A9-4769-8AB3-3B453A7CFC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24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7640" y="583128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2440" y="583128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ECA74-6E1C-4634-A2D2-300B514D6D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6960" y="235692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6280" y="235692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7640" y="583128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6960" y="583128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6280" y="5831280"/>
            <a:ext cx="218952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6C66E-8A32-47D9-A204-6FEC9AD6DE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7640" y="2356920"/>
            <a:ext cx="680076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5DA9A-0602-45D2-8CDF-A73036A6B6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680076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92DCC-C914-45E9-B467-53F808B40E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331848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2440" y="2356920"/>
            <a:ext cx="331848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20FE8-90B5-4A82-8AC1-E43D79486C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23AF9-33D6-4338-8CAB-96A08A8782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7640" y="401760"/>
            <a:ext cx="6800760" cy="779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95D65-1655-4028-9773-A403CE4AF0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2440" y="2356920"/>
            <a:ext cx="331848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7640" y="583128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F26B5-7498-428B-9FB6-E62F60FCE9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331848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24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2440" y="583128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EA522-B129-49C2-89C3-8AF64ED40F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76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2440" y="2356920"/>
            <a:ext cx="331848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7640" y="5831280"/>
            <a:ext cx="6800760" cy="31726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C7999-3A6A-456A-B070-F876E96A01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401760"/>
            <a:ext cx="6800760" cy="168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7640" y="2356920"/>
            <a:ext cx="6800760" cy="665172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183240"/>
            <a:ext cx="1758600" cy="69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5520" y="9183240"/>
            <a:ext cx="2395800" cy="69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9800" y="9183240"/>
            <a:ext cx="1758960" cy="69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fld id="{96AB65CA-994C-4426-895D-2CBA9FA9141D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360360"/>
            <a:ext cx="6178680" cy="8916840"/>
          </a:xfrm>
          <a:prstGeom prst="rect">
            <a:avLst/>
          </a:prstGeom>
          <a:ln w="0">
            <a:noFill/>
          </a:ln>
        </p:spPr>
      </p:pic>
      <p:sp>
        <p:nvSpPr>
          <p:cNvPr id="42" name="Text Box 4"/>
          <p:cNvSpPr/>
          <p:nvPr/>
        </p:nvSpPr>
        <p:spPr>
          <a:xfrm>
            <a:off x="324000" y="9433080"/>
            <a:ext cx="684036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60840" bIns="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Times New Roman"/>
              </a:rPr>
              <a:t>Figure S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983200" y="3287880"/>
            <a:ext cx="0" cy="1512720"/>
          </a:xfrm>
          <a:prstGeom prst="line">
            <a:avLst/>
          </a:prstGeom>
          <a:ln w="1260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072040" y="1415880"/>
            <a:ext cx="2627280" cy="43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Times New Roman"/>
              </a:rPr>
              <a:t>GTP-B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1" i="1" lang="fr-FR" sz="1200" spc="-1" strike="noStrike">
                <a:solidFill>
                  <a:srgbClr val="333399"/>
                </a:solidFill>
                <a:latin typeface="Times New Roman"/>
              </a:rPr>
              <a:t>Eukaryotes,</a:t>
            </a:r>
            <a:r>
              <a:rPr b="1" i="1" lang="fr-FR" sz="1200" spc="-1" strike="noStrike">
                <a:solidFill>
                  <a:srgbClr val="0000cc"/>
                </a:solidFill>
                <a:latin typeface="Times New Roman"/>
              </a:rPr>
              <a:t> </a:t>
            </a:r>
            <a:r>
              <a:rPr b="1" i="1" lang="fr-FR" sz="1200" spc="-1" strike="noStrike">
                <a:solidFill>
                  <a:srgbClr val="336600"/>
                </a:solidFill>
                <a:latin typeface="Times New Roman"/>
              </a:rPr>
              <a:t>Archaea</a:t>
            </a:r>
            <a:r>
              <a:rPr b="1" i="1" lang="fr-FR" sz="1200" spc="-1" strike="noStrike">
                <a:solidFill>
                  <a:srgbClr val="0000cc"/>
                </a:solidFill>
                <a:latin typeface="Times New Roman"/>
              </a:rPr>
              <a:t>, </a:t>
            </a:r>
            <a:r>
              <a:rPr b="1" i="1" lang="fr-FR" sz="1200" spc="-1" strike="noStrike">
                <a:solidFill>
                  <a:srgbClr val="ff0000"/>
                </a:solidFill>
                <a:latin typeface="Times New Roman"/>
              </a:rPr>
              <a:t>Mimiviridae</a:t>
            </a:r>
            <a:r>
              <a:rPr b="1" i="1" lang="fr-FR" sz="12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614840" y="4871880"/>
            <a:ext cx="0" cy="1008360"/>
          </a:xfrm>
          <a:prstGeom prst="line">
            <a:avLst/>
          </a:prstGeom>
          <a:ln w="12600">
            <a:solidFill>
              <a:srgbClr val="33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191200" y="407880"/>
            <a:ext cx="0" cy="2880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191200" y="3720960"/>
            <a:ext cx="2627280" cy="43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800080"/>
                </a:solidFill>
                <a:latin typeface="Times New Roman"/>
              </a:rPr>
              <a:t>EF-T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800080"/>
                </a:solidFill>
                <a:latin typeface="Times New Roman"/>
              </a:rPr>
              <a:t>(Bacteri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751200" y="5087880"/>
            <a:ext cx="2627280" cy="43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336600"/>
                </a:solidFill>
                <a:latin typeface="Times New Roman"/>
              </a:rPr>
              <a:t>aEF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336600"/>
                </a:solidFill>
                <a:latin typeface="Times New Roman"/>
              </a:rPr>
              <a:t>(Archae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111560" y="6311880"/>
            <a:ext cx="0" cy="217440"/>
          </a:xfrm>
          <a:prstGeom prst="line">
            <a:avLst/>
          </a:prstGeom>
          <a:ln w="1260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895560" y="6267600"/>
            <a:ext cx="19069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99"/>
                </a:solidFill>
                <a:latin typeface="Times New Roman"/>
              </a:rPr>
              <a:t>eRF-3 (Eukaryo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895560" y="5952960"/>
            <a:ext cx="187200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99"/>
                </a:solidFill>
                <a:latin typeface="Times New Roman"/>
              </a:rPr>
              <a:t>HBS1 (Eukaryo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111560" y="5952960"/>
            <a:ext cx="0" cy="352440"/>
          </a:xfrm>
          <a:prstGeom prst="line">
            <a:avLst/>
          </a:prstGeom>
          <a:ln w="1260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111560" y="6600960"/>
            <a:ext cx="0" cy="352440"/>
          </a:xfrm>
          <a:prstGeom prst="line">
            <a:avLst/>
          </a:prstGeom>
          <a:ln w="1260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895560" y="6600960"/>
            <a:ext cx="19069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99"/>
                </a:solidFill>
                <a:latin typeface="Times New Roman"/>
              </a:rPr>
              <a:t>EF-like (Eukaryo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398840" y="7824960"/>
            <a:ext cx="190656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i="1" lang="fr-FR" sz="1200" spc="-1" strike="noStrike">
                <a:solidFill>
                  <a:srgbClr val="000099"/>
                </a:solidFill>
                <a:latin typeface="Times New Roman"/>
              </a:rPr>
              <a:t>eEF-1 (Eukaryo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398840" y="6961320"/>
            <a:ext cx="0" cy="1949400"/>
          </a:xfrm>
          <a:prstGeom prst="line">
            <a:avLst/>
          </a:prstGeom>
          <a:ln w="1260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1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07T14:38:10Z</dcterms:created>
  <dc:creator>Madoui </dc:creator>
  <dc:description/>
  <dc:language>en-US</dc:language>
  <cp:lastModifiedBy>mickael</cp:lastModifiedBy>
  <dcterms:modified xsi:type="dcterms:W3CDTF">2010-10-18T13:02:04Z</dcterms:modified>
  <cp:revision>59</cp:revision>
  <dc:subject/>
  <dc:title>Diapositive 1</dc:title>
</cp:coreProperties>
</file>